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2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1.xml" ContentType="application/vnd.openxmlformats-officedocument.presentationml.slide+xml"/>
  <Override PartName="/ppt/slides/slide3.xml" ContentType="application/vnd.openxmlformats-officedocument.presentationml.slide+xml"/>
  <Override PartName="/ppt/slideLayouts/slideLayout6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5.xml" ContentType="application/vnd.openxmlformats-officedocument.presentationml.slideLayout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tableStyles.xml" ContentType="application/vnd.openxmlformats-officedocument.presentationml.tableStyles+xml"/>
  <Override PartName="/ppt/viewProps.xml" ContentType="application/vnd.openxmlformats-officedocument.presentationml.viewProps+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56" r:id="rId3"/>
    <p:sldId id="259" r:id="rId4"/>
    <p:sldId id="264" r:id="rId5"/>
    <p:sldId id="260" r:id="rId6"/>
    <p:sldId id="263" r:id="rId7"/>
    <p:sldId id="262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9" d="100"/>
          <a:sy n="99" d="100"/>
        </p:scale>
        <p:origin x="-24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9216A-1443-4465-AB3F-73FEBDF36796}" type="datetimeFigureOut">
              <a:rPr lang="en-GB" smtClean="0"/>
              <a:t>23/04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FB9D8-9914-4235-91A2-7A319E3036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06836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9216A-1443-4465-AB3F-73FEBDF36796}" type="datetimeFigureOut">
              <a:rPr lang="en-GB" smtClean="0"/>
              <a:t>23/04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FB9D8-9914-4235-91A2-7A319E3036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92821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9216A-1443-4465-AB3F-73FEBDF36796}" type="datetimeFigureOut">
              <a:rPr lang="en-GB" smtClean="0"/>
              <a:t>23/04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FB9D8-9914-4235-91A2-7A319E3036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88342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9216A-1443-4465-AB3F-73FEBDF36796}" type="datetimeFigureOut">
              <a:rPr lang="en-GB" smtClean="0"/>
              <a:t>23/04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FB9D8-9914-4235-91A2-7A319E3036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23040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9216A-1443-4465-AB3F-73FEBDF36796}" type="datetimeFigureOut">
              <a:rPr lang="en-GB" smtClean="0"/>
              <a:t>23/04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FB9D8-9914-4235-91A2-7A319E3036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44955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9216A-1443-4465-AB3F-73FEBDF36796}" type="datetimeFigureOut">
              <a:rPr lang="en-GB" smtClean="0"/>
              <a:t>23/04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FB9D8-9914-4235-91A2-7A319E3036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61586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9216A-1443-4465-AB3F-73FEBDF36796}" type="datetimeFigureOut">
              <a:rPr lang="en-GB" smtClean="0"/>
              <a:t>23/04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FB9D8-9914-4235-91A2-7A319E3036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25136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9216A-1443-4465-AB3F-73FEBDF36796}" type="datetimeFigureOut">
              <a:rPr lang="en-GB" smtClean="0"/>
              <a:t>23/04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FB9D8-9914-4235-91A2-7A319E3036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87515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9216A-1443-4465-AB3F-73FEBDF36796}" type="datetimeFigureOut">
              <a:rPr lang="en-GB" smtClean="0"/>
              <a:t>23/04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FB9D8-9914-4235-91A2-7A319E3036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25278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9216A-1443-4465-AB3F-73FEBDF36796}" type="datetimeFigureOut">
              <a:rPr lang="en-GB" smtClean="0"/>
              <a:t>23/04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FB9D8-9914-4235-91A2-7A319E3036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8104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9216A-1443-4465-AB3F-73FEBDF36796}" type="datetimeFigureOut">
              <a:rPr lang="en-GB" smtClean="0"/>
              <a:t>23/04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AFB9D8-9914-4235-91A2-7A319E3036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3856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29216A-1443-4465-AB3F-73FEBDF36796}" type="datetimeFigureOut">
              <a:rPr lang="en-GB" smtClean="0"/>
              <a:t>23/04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AFB9D8-9914-4235-91A2-7A319E3036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2842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84368" y="548680"/>
            <a:ext cx="1066800" cy="5981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323528" y="1988840"/>
            <a:ext cx="6768752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miRNA_5p: GGCAAGTCTGTCCTTGGCTAC</a:t>
            </a:r>
          </a:p>
          <a:p>
            <a:r>
              <a:rPr lang="en-GB" dirty="0">
                <a:latin typeface="Courier New" panose="02070309020205020404" pitchFamily="49" charset="0"/>
                <a:cs typeface="Courier New" panose="02070309020205020404" pitchFamily="49" charset="0"/>
              </a:rPr>
              <a:t>miRNA_3p: CAGCCAAGGATGACTTGCCGC</a:t>
            </a:r>
            <a:endParaRPr lang="en-GB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GGCAAGTCTGTCCTTGGCTAC_PH01000289/15663-15683 </a:t>
            </a:r>
          </a:p>
          <a:p>
            <a:r>
              <a:rPr lang="en-GB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UGCAGCCAAGGAUGACUUGCCGCCGACCGGCAGUGUCGCCGCCGGCAGUCUGUGACAUGCUGCAUGGUUGCCCGGCAAGUCUGUCCUUGGCUACA</a:t>
            </a:r>
            <a:endParaRPr lang="en-GB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55617399"/>
              </p:ext>
            </p:extLst>
          </p:nvPr>
        </p:nvGraphicFramePr>
        <p:xfrm>
          <a:off x="395536" y="620688"/>
          <a:ext cx="6654800" cy="952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9600"/>
                <a:gridCol w="2019300"/>
                <a:gridCol w="609600"/>
                <a:gridCol w="609600"/>
                <a:gridCol w="609600"/>
                <a:gridCol w="2197100"/>
              </a:tblGrid>
              <a:tr h="190500">
                <a:tc rowSpan="5"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</a:rPr>
                        <a:t>New-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Sequence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Length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root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leaf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genomic Location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</a:rPr>
                        <a:t>GGCAAGTCTGTCCTTGGCTAC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9525" marB="0" anchor="b"/>
                </a:tc>
                <a:tc rowSpan="4"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2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rowSpan="4"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4899.03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rowSpan="4"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4478.4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PH01003459/60524-6054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PH01000289/15663-1568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</a:rPr>
                        <a:t>PH01000289/65843-65863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</a:rPr>
                        <a:t>PH01000289/120711-12073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105896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56376" y="407863"/>
            <a:ext cx="800100" cy="5981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323528" y="2020292"/>
            <a:ext cx="7047655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miRNA_5p : CAGCCAAGGAUGACUUGCCG</a:t>
            </a:r>
          </a:p>
          <a:p>
            <a:r>
              <a:rPr lang="en-GB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miRNA_3p: </a:t>
            </a:r>
            <a:r>
              <a:rPr lang="en-GB" dirty="0">
                <a:latin typeface="Courier New" panose="02070309020205020404" pitchFamily="49" charset="0"/>
                <a:cs typeface="Courier New" panose="02070309020205020404" pitchFamily="49" charset="0"/>
              </a:rPr>
              <a:t>GGCAGGTCTGTCCTTGGCTAC</a:t>
            </a:r>
          </a:p>
          <a:p>
            <a:endParaRPr lang="en-GB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CAGCCAAGGAUGACUUGCCG_PH01000224/320759-320778 </a:t>
            </a:r>
          </a:p>
          <a:p>
            <a:r>
              <a:rPr lang="en-GB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UGCAGCCAAGGAUGACUUGCCGGCUCCUGGUGCUGGGGAAAUCUCAGCUUUGUUGAGCCUCAGAUAGUUAGCCGGCAGGUCUGUCCUUGGCUACA</a:t>
            </a:r>
            <a:endParaRPr lang="en-GB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41578480"/>
              </p:ext>
            </p:extLst>
          </p:nvPr>
        </p:nvGraphicFramePr>
        <p:xfrm>
          <a:off x="107504" y="908720"/>
          <a:ext cx="7920881" cy="53827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53021"/>
                <a:gridCol w="1831885"/>
                <a:gridCol w="553021"/>
                <a:gridCol w="553021"/>
                <a:gridCol w="553021"/>
                <a:gridCol w="1987421"/>
                <a:gridCol w="1889491"/>
              </a:tblGrid>
              <a:tr h="179424">
                <a:tc rowSpan="2"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Normalized Expression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</a:tr>
              <a:tr h="179424">
                <a:tc vMerge="1"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Sequence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Length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root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leaf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genomic Location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miRNA*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</a:tr>
              <a:tr h="17942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New-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GGCAGGTCTGTCCTTGGCTAC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806.0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41.8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PH01000224/320759-32077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CAGCCAAGGAUGACUUGCCG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971" marR="8971" marT="8971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964209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04917" y="454712"/>
            <a:ext cx="1104900" cy="5972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323528" y="1916832"/>
            <a:ext cx="756084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miRNA_5p: TCGTCGCAGGAGAGATGACGC</a:t>
            </a:r>
          </a:p>
          <a:p>
            <a:r>
              <a:rPr lang="en-GB" dirty="0">
                <a:latin typeface="Courier New" panose="02070309020205020404" pitchFamily="49" charset="0"/>
                <a:cs typeface="Courier New" panose="02070309020205020404" pitchFamily="49" charset="0"/>
              </a:rPr>
              <a:t>miRNA_3p: </a:t>
            </a:r>
            <a:r>
              <a:rPr lang="en-GB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CGTCGTCTTCCTTGCGAC,GCGTCGTCTTCCTTGCGACGA</a:t>
            </a:r>
          </a:p>
          <a:p>
            <a:endParaRPr lang="en-GB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TCGTCGCAGGAGAGATGACGC_PH01001122/158033-158053 </a:t>
            </a:r>
          </a:p>
          <a:p>
            <a:r>
              <a:rPr lang="en-GB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UCGUCGCAGGAGAGAUGACGCCCACGCCGGCCAGCUGAUUCCGUCCGCCGGCCGGCCGGCCGGCGGUGGCGUCGUCUUCCUUGCGACGA</a:t>
            </a:r>
            <a:endParaRPr lang="en-GB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63361202"/>
              </p:ext>
            </p:extLst>
          </p:nvPr>
        </p:nvGraphicFramePr>
        <p:xfrm>
          <a:off x="147838" y="980728"/>
          <a:ext cx="7912220" cy="71769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52416"/>
                <a:gridCol w="1829883"/>
                <a:gridCol w="552416"/>
                <a:gridCol w="552416"/>
                <a:gridCol w="552416"/>
                <a:gridCol w="1985248"/>
                <a:gridCol w="1887425"/>
              </a:tblGrid>
              <a:tr h="179424">
                <a:tc rowSpan="2"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Normalized Expression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</a:tr>
              <a:tr h="179424">
                <a:tc vMerge="1"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Sequence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Length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root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leaf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genomic Location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miRNA*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</a:tr>
              <a:tr h="35884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New-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TCGTCGCAGGAGAGATGACGC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80.9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727.0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PH01001122/158033-15805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TGGCGTCGTCTTCCTTGCGAC, GCGTCGTCTTCCTTGCGACG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971" marR="8971" marT="8971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888874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56376" y="415916"/>
            <a:ext cx="1085850" cy="5972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79512" y="1484784"/>
            <a:ext cx="7776864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miRNA_5p: TGGGCGAGTCTTCTTGGCTATG</a:t>
            </a:r>
          </a:p>
          <a:p>
            <a:r>
              <a:rPr lang="en-GB" dirty="0">
                <a:latin typeface="Courier New" panose="02070309020205020404" pitchFamily="49" charset="0"/>
                <a:cs typeface="Courier New" panose="02070309020205020404" pitchFamily="49" charset="0"/>
              </a:rPr>
              <a:t>miRNA_3p: </a:t>
            </a:r>
            <a:r>
              <a:rPr lang="en-GB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AGCCAAGAATGGCTTGCCTA,TAGCCAAGAATGGCTTGCCTAC</a:t>
            </a:r>
          </a:p>
          <a:p>
            <a:endParaRPr lang="en-GB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TGGGCGAGTCTTCTTGGCTATG_PH01002310/112516-112537 </a:t>
            </a:r>
          </a:p>
          <a:p>
            <a:r>
              <a:rPr lang="en-GB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UAUUAGCCAAGAAUGGCUUGCCUACUCCCACUUUUUGUGUCAUCAGUGGGACAAACUUGGAGUCCUGAUGAUGGAUGAAAUGUGGUUGCGUGGGCGAGUCUUCUUGGCUAUGAGAGU</a:t>
            </a:r>
            <a:endParaRPr lang="en-GB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91129922"/>
              </p:ext>
            </p:extLst>
          </p:nvPr>
        </p:nvGraphicFramePr>
        <p:xfrm>
          <a:off x="181414" y="548680"/>
          <a:ext cx="7920881" cy="69964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53021"/>
                <a:gridCol w="1831885"/>
                <a:gridCol w="553021"/>
                <a:gridCol w="553021"/>
                <a:gridCol w="553021"/>
                <a:gridCol w="1987421"/>
                <a:gridCol w="1889491"/>
              </a:tblGrid>
              <a:tr h="144016">
                <a:tc rowSpan="2"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Normalized Expression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</a:tr>
              <a:tr h="179424">
                <a:tc vMerge="1"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Sequence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Length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root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leaf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genomic Location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miRNA*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</a:tr>
              <a:tr h="358849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New-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TGGGCGAGTCTTCTTGGCTATG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2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1.5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79.1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PH01002310/112516-11253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TTAGCCAAGAATGGCTTGCCTA, TAGCCAAGAATGGCTTGCCTAC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971" marR="8971" marT="8971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018028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56376" y="438150"/>
            <a:ext cx="971550" cy="5981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251520" y="2060848"/>
            <a:ext cx="662473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miRNA_5p: TCGGTTGCATTTGTAGTCCTA</a:t>
            </a:r>
          </a:p>
          <a:p>
            <a:r>
              <a:rPr lang="en-GB" dirty="0">
                <a:latin typeface="Courier New" panose="02070309020205020404" pitchFamily="49" charset="0"/>
                <a:cs typeface="Courier New" panose="02070309020205020404" pitchFamily="49" charset="0"/>
              </a:rPr>
              <a:t>miRNA_3p: TACGACTACAAATGCAACCGA</a:t>
            </a:r>
            <a:endParaRPr lang="en-GB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GB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TCGGTTGCATTTGTAGTCCTA_PH01002844/54227-54247 </a:t>
            </a:r>
          </a:p>
          <a:p>
            <a:r>
              <a:rPr lang="en-GB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UACGACUACAAAUGCAACCGAUCCCGGGUCGCUACCCGGGAUCGGUUGACGACGCGGGAUCGGUUGCAUUUGUAGUCCUAUCC</a:t>
            </a:r>
            <a:endParaRPr lang="en-GB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93357408"/>
              </p:ext>
            </p:extLst>
          </p:nvPr>
        </p:nvGraphicFramePr>
        <p:xfrm>
          <a:off x="107504" y="1124744"/>
          <a:ext cx="7740354" cy="53827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40417"/>
                <a:gridCol w="1790134"/>
                <a:gridCol w="540417"/>
                <a:gridCol w="540417"/>
                <a:gridCol w="540417"/>
                <a:gridCol w="1942125"/>
                <a:gridCol w="1846427"/>
              </a:tblGrid>
              <a:tr h="179424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Normalized Expression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</a:tr>
              <a:tr h="179424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Sequence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Length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root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leaf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genomic Location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miRNA*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</a:tr>
              <a:tr h="17942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New-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TCGGTTGCATTTGTAGTCCTA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0.5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74.6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PH01002844/54227-5424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TACGACTACAAATGCAACCG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971" marR="8971" marT="8971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8888747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67544" y="1124744"/>
            <a:ext cx="7416824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miRNA_5p: CUCCGAAUUCUUGACAAACCGA</a:t>
            </a:r>
          </a:p>
          <a:p>
            <a:r>
              <a:rPr lang="en-GB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miRNA_3p: no</a:t>
            </a:r>
          </a:p>
          <a:p>
            <a:endParaRPr lang="en-GB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CUCCGAAUUCUUGACAAACCGA_PH01001421/264619-264640 </a:t>
            </a:r>
          </a:p>
          <a:p>
            <a:r>
              <a:rPr lang="en-GB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UCCGAAUUCUUGACAAACCGAUCAAGGGUUUUUUCCGAUUGUGCGUGAUCAAGGGAUAUUUCCUUGGAGGCAGAAUCCACUGGACUUCUGUCUUCUGAUCGUGUCCAUUAGUGCACGUCUGGUAGAAGCUUUAGGUUUGGUAUUGCAUCAGUUCAGGAUU</a:t>
            </a:r>
            <a:endParaRPr lang="en-GB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84368" y="332656"/>
            <a:ext cx="723900" cy="5953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24070179"/>
              </p:ext>
            </p:extLst>
          </p:nvPr>
        </p:nvGraphicFramePr>
        <p:xfrm>
          <a:off x="467544" y="4077072"/>
          <a:ext cx="7463172" cy="53827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33843"/>
                <a:gridCol w="1811618"/>
                <a:gridCol w="520686"/>
                <a:gridCol w="520686"/>
                <a:gridCol w="520686"/>
                <a:gridCol w="1876641"/>
                <a:gridCol w="1779012"/>
              </a:tblGrid>
              <a:tr h="358848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Sequenc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Length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root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leaf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genomic Locatio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miRNA*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</a:tr>
              <a:tr h="17942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New-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CTCCGAATTCTTGACAAACCGA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2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180.9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00.7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PH01001421/264619-26464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971" marR="8971" marT="8971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469327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64288" y="548680"/>
            <a:ext cx="1685925" cy="5915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251520" y="2060848"/>
            <a:ext cx="712879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miRNA_5p: TTGCACTTGTCGACGGAGTTCC</a:t>
            </a:r>
          </a:p>
          <a:p>
            <a:r>
              <a:rPr lang="en-GB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miRNA_3p: no</a:t>
            </a:r>
          </a:p>
          <a:p>
            <a:endParaRPr lang="en-GB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GB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&gt;TTGCACTTGTCGACGGAGTTCC_PH01000975/466681-466702 </a:t>
            </a:r>
          </a:p>
          <a:p>
            <a:r>
              <a:rPr lang="en-GB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UUGCACUUGUCGACGGAGUUCCUGGUUCUCCCUGUGAAUAUUCUGGAUGAUAACAGUAGACGC</a:t>
            </a:r>
            <a:endParaRPr lang="en-GB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68127713"/>
              </p:ext>
            </p:extLst>
          </p:nvPr>
        </p:nvGraphicFramePr>
        <p:xfrm>
          <a:off x="243071" y="980728"/>
          <a:ext cx="7488832" cy="71769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22856"/>
                <a:gridCol w="1731964"/>
                <a:gridCol w="522856"/>
                <a:gridCol w="522856"/>
                <a:gridCol w="522856"/>
                <a:gridCol w="1879016"/>
                <a:gridCol w="1786428"/>
              </a:tblGrid>
              <a:tr h="179424">
                <a:tc rowSpan="2"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Normalized Expression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</a:tr>
              <a:tr h="179424">
                <a:tc vMerge="1"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Sequenc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Length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root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leaf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genomic Location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miRNA*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</a:tr>
              <a:tr h="17942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New-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TTGCACTTGTCGACGGAGTTCC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46.2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49.1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PH01000975/466681-46670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no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971" marR="8971" marT="8971" marB="0" anchor="b"/>
                </a:tc>
              </a:tr>
              <a:tr h="179424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PH01205740/575-59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8971" marR="8971" marT="8971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971" marR="8971" marT="8971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558754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5</TotalTime>
  <Words>183</Words>
  <Application>Microsoft Office PowerPoint</Application>
  <PresentationFormat>On-screen Show (4:3)</PresentationFormat>
  <Paragraphs>133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East Angli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rina Mohorianu</dc:creator>
  <cp:lastModifiedBy>Ping Xu (BIO)</cp:lastModifiedBy>
  <cp:revision>10</cp:revision>
  <dcterms:created xsi:type="dcterms:W3CDTF">2014-03-20T13:58:25Z</dcterms:created>
  <dcterms:modified xsi:type="dcterms:W3CDTF">2014-04-23T13:40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-931618836</vt:i4>
  </property>
  <property fmtid="{D5CDD505-2E9C-101B-9397-08002B2CF9AE}" pid="3" name="_NewReviewCycle">
    <vt:lpwstr/>
  </property>
  <property fmtid="{D5CDD505-2E9C-101B-9397-08002B2CF9AE}" pid="4" name="_EmailSubject">
    <vt:lpwstr>manuscript update</vt:lpwstr>
  </property>
  <property fmtid="{D5CDD505-2E9C-101B-9397-08002B2CF9AE}" pid="5" name="_AuthorEmail">
    <vt:lpwstr>P.Xu3@uea.ac.uk</vt:lpwstr>
  </property>
  <property fmtid="{D5CDD505-2E9C-101B-9397-08002B2CF9AE}" pid="6" name="_AuthorEmailDisplayName">
    <vt:lpwstr>Ping Xu (BIO)</vt:lpwstr>
  </property>
</Properties>
</file>